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 bookmarkIdSeed="2">
  <p:sldMasterIdLst>
    <p:sldMasterId id="2147483648" r:id="rId1"/>
  </p:sldMasterIdLst>
  <p:notesMasterIdLst>
    <p:notesMasterId r:id="rId3"/>
  </p:notesMasterIdLst>
  <p:sldIdLst>
    <p:sldId id="278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7" roundtripDataSignature="AMtx7mh9N9kfoRVhKwgX4OZmhL7vcqOgc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4381592A-5D5C-46ED-8E48-2ADFE3FF2D64}">
  <a:tblStyle styleId="{4381592A-5D5C-46ED-8E48-2ADFE3FF2D64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7424E599-DE82-460D-B708-FAB9E1C17B56}" styleName="Table_1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tcBdr/>
        <a:fill>
          <a:solidFill>
            <a:srgbClr val="CDD4EA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DD4EA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391" autoAdjust="0"/>
    <p:restoredTop sz="91640" autoAdjust="0"/>
  </p:normalViewPr>
  <p:slideViewPr>
    <p:cSldViewPr snapToGrid="0">
      <p:cViewPr varScale="1">
        <p:scale>
          <a:sx n="107" d="100"/>
          <a:sy n="107" d="100"/>
        </p:scale>
        <p:origin x="10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21" Type="http://schemas.openxmlformats.org/officeDocument/2006/relationships/tableStyles" Target="tableStyles.xml"/><Relationship Id="rId17" Type="http://customschemas.google.com/relationships/presentationmetadata" Target="metadata"/><Relationship Id="rId2" Type="http://schemas.openxmlformats.org/officeDocument/2006/relationships/slide" Target="slides/slide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1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Table S3A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cordance between assays for tumor suppressor aberrancy calls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28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IHC: Immunohistochemistry; stDNA: solid tumor next generation sequencing; ctDNA:</a:t>
            </a:r>
            <a:r>
              <a:rPr lang="en-US" sz="28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circulating tumor next generation sequencing; stDNA adjusted: solid tumor next generation sequencing incorporating analysis of </a:t>
            </a:r>
            <a:r>
              <a:rPr lang="en-US" sz="28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eletion CNVs using a threshold of copy number ≤1.5 which was not validated for this assay</a:t>
            </a:r>
            <a:endParaRPr lang="en-US" sz="2800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2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405221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8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8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7" name="Google Shape;47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9" name="Google Shape;49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2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12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3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3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4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5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5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8610588"/>
              </p:ext>
            </p:extLst>
          </p:nvPr>
        </p:nvGraphicFramePr>
        <p:xfrm>
          <a:off x="57151" y="484187"/>
          <a:ext cx="5768975" cy="3032897"/>
        </p:xfrm>
        <a:graphic>
          <a:graphicData uri="http://schemas.openxmlformats.org/drawingml/2006/table">
            <a:tbl>
              <a:tblPr/>
              <a:tblGrid>
                <a:gridCol w="1314450">
                  <a:extLst>
                    <a:ext uri="{9D8B030D-6E8A-4147-A177-3AD203B41FA5}">
                      <a16:colId xmlns:a16="http://schemas.microsoft.com/office/drawing/2014/main" val="2936542996"/>
                    </a:ext>
                  </a:extLst>
                </a:gridCol>
                <a:gridCol w="1435735">
                  <a:extLst>
                    <a:ext uri="{9D8B030D-6E8A-4147-A177-3AD203B41FA5}">
                      <a16:colId xmlns:a16="http://schemas.microsoft.com/office/drawing/2014/main" val="1023012897"/>
                    </a:ext>
                  </a:extLst>
                </a:gridCol>
                <a:gridCol w="904240">
                  <a:extLst>
                    <a:ext uri="{9D8B030D-6E8A-4147-A177-3AD203B41FA5}">
                      <a16:colId xmlns:a16="http://schemas.microsoft.com/office/drawing/2014/main" val="571121637"/>
                    </a:ext>
                  </a:extLst>
                </a:gridCol>
                <a:gridCol w="611505">
                  <a:extLst>
                    <a:ext uri="{9D8B030D-6E8A-4147-A177-3AD203B41FA5}">
                      <a16:colId xmlns:a16="http://schemas.microsoft.com/office/drawing/2014/main" val="328938014"/>
                    </a:ext>
                  </a:extLst>
                </a:gridCol>
                <a:gridCol w="131445">
                  <a:extLst>
                    <a:ext uri="{9D8B030D-6E8A-4147-A177-3AD203B41FA5}">
                      <a16:colId xmlns:a16="http://schemas.microsoft.com/office/drawing/2014/main" val="634424675"/>
                    </a:ext>
                  </a:extLst>
                </a:gridCol>
                <a:gridCol w="432435">
                  <a:extLst>
                    <a:ext uri="{9D8B030D-6E8A-4147-A177-3AD203B41FA5}">
                      <a16:colId xmlns:a16="http://schemas.microsoft.com/office/drawing/2014/main" val="295759144"/>
                    </a:ext>
                  </a:extLst>
                </a:gridCol>
                <a:gridCol w="939165">
                  <a:extLst>
                    <a:ext uri="{9D8B030D-6E8A-4147-A177-3AD203B41FA5}">
                      <a16:colId xmlns:a16="http://schemas.microsoft.com/office/drawing/2014/main" val="41452349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83509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0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33, 0.18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45205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62617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10139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71108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21, 0.41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8432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39214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9479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30015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06, 0.75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70910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69362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32307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07779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20, 0.47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79829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93523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91397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70497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22, 0.81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06733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53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37318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2067018"/>
                  </a:ext>
                </a:extLst>
              </a:tr>
            </a:tbl>
          </a:graphicData>
        </a:graphic>
      </p:graphicFrame>
      <p:sp>
        <p:nvSpPr>
          <p:cNvPr id="19" name="Rectangle 5"/>
          <p:cNvSpPr>
            <a:spLocks noChangeArrowheads="1"/>
          </p:cNvSpPr>
          <p:nvPr/>
        </p:nvSpPr>
        <p:spPr bwMode="auto">
          <a:xfrm>
            <a:off x="1" y="484187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0" name="Tab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4020883"/>
              </p:ext>
            </p:extLst>
          </p:nvPr>
        </p:nvGraphicFramePr>
        <p:xfrm>
          <a:off x="2883694" y="3606950"/>
          <a:ext cx="5992712" cy="3159066"/>
        </p:xfrm>
        <a:graphic>
          <a:graphicData uri="http://schemas.openxmlformats.org/drawingml/2006/table">
            <a:tbl>
              <a:tblPr/>
              <a:tblGrid>
                <a:gridCol w="1347828">
                  <a:extLst>
                    <a:ext uri="{9D8B030D-6E8A-4147-A177-3AD203B41FA5}">
                      <a16:colId xmlns:a16="http://schemas.microsoft.com/office/drawing/2014/main" val="2814011767"/>
                    </a:ext>
                  </a:extLst>
                </a:gridCol>
                <a:gridCol w="1472192">
                  <a:extLst>
                    <a:ext uri="{9D8B030D-6E8A-4147-A177-3AD203B41FA5}">
                      <a16:colId xmlns:a16="http://schemas.microsoft.com/office/drawing/2014/main" val="90674561"/>
                    </a:ext>
                  </a:extLst>
                </a:gridCol>
                <a:gridCol w="1035050">
                  <a:extLst>
                    <a:ext uri="{9D8B030D-6E8A-4147-A177-3AD203B41FA5}">
                      <a16:colId xmlns:a16="http://schemas.microsoft.com/office/drawing/2014/main" val="2835066309"/>
                    </a:ext>
                  </a:extLst>
                </a:gridCol>
                <a:gridCol w="627033">
                  <a:extLst>
                    <a:ext uri="{9D8B030D-6E8A-4147-A177-3AD203B41FA5}">
                      <a16:colId xmlns:a16="http://schemas.microsoft.com/office/drawing/2014/main" val="1538219655"/>
                    </a:ext>
                  </a:extLst>
                </a:gridCol>
                <a:gridCol w="104180">
                  <a:extLst>
                    <a:ext uri="{9D8B030D-6E8A-4147-A177-3AD203B41FA5}">
                      <a16:colId xmlns:a16="http://schemas.microsoft.com/office/drawing/2014/main" val="3959385443"/>
                    </a:ext>
                  </a:extLst>
                </a:gridCol>
                <a:gridCol w="443416">
                  <a:extLst>
                    <a:ext uri="{9D8B030D-6E8A-4147-A177-3AD203B41FA5}">
                      <a16:colId xmlns:a16="http://schemas.microsoft.com/office/drawing/2014/main" val="2681905646"/>
                    </a:ext>
                  </a:extLst>
                </a:gridCol>
                <a:gridCol w="963013">
                  <a:extLst>
                    <a:ext uri="{9D8B030D-6E8A-4147-A177-3AD203B41FA5}">
                      <a16:colId xmlns:a16="http://schemas.microsoft.com/office/drawing/2014/main" val="123030407"/>
                    </a:ext>
                  </a:extLst>
                </a:gridCol>
              </a:tblGrid>
              <a:tr h="17624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9477238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2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01, 0.47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5951702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1826284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4869705"/>
                  </a:ext>
                </a:extLst>
              </a:tr>
              <a:tr h="17624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6451701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0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26, 0.17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3797434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8654138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5187707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4553145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2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24, 0.77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2730985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7505358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440866"/>
                  </a:ext>
                </a:extLst>
              </a:tr>
              <a:tr h="30508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4465687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20, 0.80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4762433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3661702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6041820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9152140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11, 0.40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0614385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4918409"/>
                  </a:ext>
                </a:extLst>
              </a:tr>
              <a:tr h="14677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9087029"/>
                  </a:ext>
                </a:extLst>
              </a:tr>
            </a:tbl>
          </a:graphicData>
        </a:graphic>
      </p:graphicFrame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1069567"/>
              </p:ext>
            </p:extLst>
          </p:nvPr>
        </p:nvGraphicFramePr>
        <p:xfrm>
          <a:off x="5969001" y="498692"/>
          <a:ext cx="5823585" cy="3032897"/>
        </p:xfrm>
        <a:graphic>
          <a:graphicData uri="http://schemas.openxmlformats.org/drawingml/2006/table">
            <a:tbl>
              <a:tblPr/>
              <a:tblGrid>
                <a:gridCol w="1314450">
                  <a:extLst>
                    <a:ext uri="{9D8B030D-6E8A-4147-A177-3AD203B41FA5}">
                      <a16:colId xmlns:a16="http://schemas.microsoft.com/office/drawing/2014/main" val="1592403325"/>
                    </a:ext>
                  </a:extLst>
                </a:gridCol>
                <a:gridCol w="1435735">
                  <a:extLst>
                    <a:ext uri="{9D8B030D-6E8A-4147-A177-3AD203B41FA5}">
                      <a16:colId xmlns:a16="http://schemas.microsoft.com/office/drawing/2014/main" val="59588309"/>
                    </a:ext>
                  </a:extLst>
                </a:gridCol>
                <a:gridCol w="958850">
                  <a:extLst>
                    <a:ext uri="{9D8B030D-6E8A-4147-A177-3AD203B41FA5}">
                      <a16:colId xmlns:a16="http://schemas.microsoft.com/office/drawing/2014/main" val="3222025195"/>
                    </a:ext>
                  </a:extLst>
                </a:gridCol>
                <a:gridCol w="611505">
                  <a:extLst>
                    <a:ext uri="{9D8B030D-6E8A-4147-A177-3AD203B41FA5}">
                      <a16:colId xmlns:a16="http://schemas.microsoft.com/office/drawing/2014/main" val="3197232680"/>
                    </a:ext>
                  </a:extLst>
                </a:gridCol>
                <a:gridCol w="131445">
                  <a:extLst>
                    <a:ext uri="{9D8B030D-6E8A-4147-A177-3AD203B41FA5}">
                      <a16:colId xmlns:a16="http://schemas.microsoft.com/office/drawing/2014/main" val="1773810534"/>
                    </a:ext>
                  </a:extLst>
                </a:gridCol>
                <a:gridCol w="432435">
                  <a:extLst>
                    <a:ext uri="{9D8B030D-6E8A-4147-A177-3AD203B41FA5}">
                      <a16:colId xmlns:a16="http://schemas.microsoft.com/office/drawing/2014/main" val="688889184"/>
                    </a:ext>
                  </a:extLst>
                </a:gridCol>
                <a:gridCol w="939165">
                  <a:extLst>
                    <a:ext uri="{9D8B030D-6E8A-4147-A177-3AD203B41FA5}">
                      <a16:colId xmlns:a16="http://schemas.microsoft.com/office/drawing/2014/main" val="436557037"/>
                    </a:ext>
                  </a:extLst>
                </a:gridCol>
              </a:tblGrid>
              <a:tr h="16300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7105175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2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21, 0.79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549777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4860227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2524217"/>
                  </a:ext>
                </a:extLst>
              </a:tr>
              <a:tr h="16300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099802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22, 0.92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5248916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9399690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5363273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0211971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13, 1.00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6558139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9747225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7635565"/>
                  </a:ext>
                </a:extLst>
              </a:tr>
              <a:tr h="16300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8781442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n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14, 0.29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7843849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HC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9891398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2777900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DNAabn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1387963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r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2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-0.01, 0.44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7851920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</a:t>
                      </a:r>
                      <a:r>
                        <a:rPr lang="en-US" sz="900" b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DNA 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usted</a:t>
                      </a:r>
                      <a:r>
                        <a:rPr lang="en-US" sz="900" b="1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6901662"/>
                  </a:ext>
                </a:extLst>
              </a:tr>
              <a:tr h="13582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5875" marR="1587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1255540"/>
                  </a:ext>
                </a:extLst>
              </a:tr>
            </a:tbl>
          </a:graphicData>
        </a:graphic>
      </p:graphicFrame>
      <p:sp>
        <p:nvSpPr>
          <p:cNvPr id="22" name="Rectangle 21"/>
          <p:cNvSpPr/>
          <p:nvPr/>
        </p:nvSpPr>
        <p:spPr>
          <a:xfrm>
            <a:off x="3552676" y="104370"/>
            <a:ext cx="5086650" cy="28995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3A. Concordance between assays for tumor suppressor aberrancy calls.</a:t>
            </a:r>
            <a:endParaRPr lang="en-US" sz="105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970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31</TotalTime>
  <Words>627</Words>
  <Application>Microsoft Office PowerPoint</Application>
  <PresentationFormat>Widescreen</PresentationFormat>
  <Paragraphs>4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ll, Brittany Leigh</dc:creator>
  <cp:lastModifiedBy>Viscuse, Paul *HS</cp:lastModifiedBy>
  <cp:revision>98</cp:revision>
  <dcterms:created xsi:type="dcterms:W3CDTF">2022-03-03T21:57:53Z</dcterms:created>
  <dcterms:modified xsi:type="dcterms:W3CDTF">2023-09-07T19:40:06Z</dcterms:modified>
</cp:coreProperties>
</file>